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  <p:sldId id="260" r:id="rId4"/>
    <p:sldId id="262" r:id="rId5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014" autoAdjust="0"/>
    <p:restoredTop sz="94660"/>
  </p:normalViewPr>
  <p:slideViewPr>
    <p:cSldViewPr snapToGrid="0">
      <p:cViewPr varScale="1">
        <p:scale>
          <a:sx n="56" d="100"/>
          <a:sy n="56" d="100"/>
        </p:scale>
        <p:origin x="2160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image" Target="../media/image3.e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image" Target="../media/image5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7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 smtClean="0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08ACD1-F099-42D1-8FA8-5B3159C0A79F}" type="datetimeFigureOut">
              <a:rPr lang="en-GB" smtClean="0"/>
              <a:t>12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1990B-9818-43EA-9B02-882DA20FF701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364133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08ACD1-F099-42D1-8FA8-5B3159C0A79F}" type="datetimeFigureOut">
              <a:rPr lang="en-GB" smtClean="0"/>
              <a:t>12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1990B-9818-43EA-9B02-882DA20FF701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82942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08ACD1-F099-42D1-8FA8-5B3159C0A79F}" type="datetimeFigureOut">
              <a:rPr lang="en-GB" smtClean="0"/>
              <a:t>12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1990B-9818-43EA-9B02-882DA20FF701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25189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08ACD1-F099-42D1-8FA8-5B3159C0A79F}" type="datetimeFigureOut">
              <a:rPr lang="en-GB" smtClean="0"/>
              <a:t>12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1990B-9818-43EA-9B02-882DA20FF701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882527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08ACD1-F099-42D1-8FA8-5B3159C0A79F}" type="datetimeFigureOut">
              <a:rPr lang="en-GB" smtClean="0"/>
              <a:t>12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1990B-9818-43EA-9B02-882DA20FF701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329783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08ACD1-F099-42D1-8FA8-5B3159C0A79F}" type="datetimeFigureOut">
              <a:rPr lang="en-GB" smtClean="0"/>
              <a:t>12/1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1990B-9818-43EA-9B02-882DA20FF701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537148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08ACD1-F099-42D1-8FA8-5B3159C0A79F}" type="datetimeFigureOut">
              <a:rPr lang="en-GB" smtClean="0"/>
              <a:t>12/11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1990B-9818-43EA-9B02-882DA20FF701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664481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08ACD1-F099-42D1-8FA8-5B3159C0A79F}" type="datetimeFigureOut">
              <a:rPr lang="en-GB" smtClean="0"/>
              <a:t>12/11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1990B-9818-43EA-9B02-882DA20FF701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801288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08ACD1-F099-42D1-8FA8-5B3159C0A79F}" type="datetimeFigureOut">
              <a:rPr lang="en-GB" smtClean="0"/>
              <a:t>12/11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1990B-9818-43EA-9B02-882DA20FF701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757749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08ACD1-F099-42D1-8FA8-5B3159C0A79F}" type="datetimeFigureOut">
              <a:rPr lang="en-GB" smtClean="0"/>
              <a:t>12/1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1990B-9818-43EA-9B02-882DA20FF701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936087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 smtClean="0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 smtClean="0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08ACD1-F099-42D1-8FA8-5B3159C0A79F}" type="datetimeFigureOut">
              <a:rPr lang="en-GB" smtClean="0"/>
              <a:t>12/1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441990B-9818-43EA-9B02-882DA20FF701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74431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08ACD1-F099-42D1-8FA8-5B3159C0A79F}" type="datetimeFigureOut">
              <a:rPr lang="en-GB" smtClean="0"/>
              <a:t>12/1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441990B-9818-43EA-9B02-882DA20FF701}" type="slidenum">
              <a:rPr lang="en-GB" smtClean="0"/>
              <a:t>‹N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535169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4.emf"/><Relationship Id="rId5" Type="http://schemas.openxmlformats.org/officeDocument/2006/relationships/oleObject" Target="../embeddings/oleObject4.bin"/><Relationship Id="rId4" Type="http://schemas.openxmlformats.org/officeDocument/2006/relationships/image" Target="../media/image3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6.emf"/><Relationship Id="rId5" Type="http://schemas.openxmlformats.org/officeDocument/2006/relationships/oleObject" Target="../embeddings/oleObject6.bin"/><Relationship Id="rId4" Type="http://schemas.openxmlformats.org/officeDocument/2006/relationships/image" Target="../media/image5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7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4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CasellaDiTesto 3"/>
          <p:cNvSpPr txBox="1"/>
          <p:nvPr/>
        </p:nvSpPr>
        <p:spPr>
          <a:xfrm>
            <a:off x="0" y="0"/>
            <a:ext cx="61722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it-IT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it-IT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File 2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 list of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s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presenting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he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evel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fferent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lavonoids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in control and </a:t>
            </a:r>
            <a:r>
              <a:rPr lang="it-IT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hAN4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RCs</a:t>
            </a:r>
            <a:r>
              <a:rPr lang="it-IT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graphicFrame>
        <p:nvGraphicFramePr>
          <p:cNvPr id="6" name="Oggetto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63992861"/>
              </p:ext>
            </p:extLst>
          </p:nvPr>
        </p:nvGraphicFramePr>
        <p:xfrm>
          <a:off x="931406" y="268410"/>
          <a:ext cx="5118666" cy="472840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0" name="Prism 8" r:id="rId3" imgW="6887725" imgH="6363401" progId="Prism8.Document">
                  <p:embed/>
                </p:oleObj>
              </mc:Choice>
              <mc:Fallback>
                <p:oleObj name="Prism 8" r:id="rId3" imgW="6887725" imgH="6363401" progId="Prism8.Document">
                  <p:embed/>
                  <p:pic>
                    <p:nvPicPr>
                      <p:cNvPr id="2" name="Oggetto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931406" y="268410"/>
                        <a:ext cx="5118666" cy="472840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ggetto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7211758"/>
              </p:ext>
            </p:extLst>
          </p:nvPr>
        </p:nvGraphicFramePr>
        <p:xfrm>
          <a:off x="1006117" y="5091175"/>
          <a:ext cx="4969244" cy="459037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1" name="Prism 8" r:id="rId5" imgW="6887725" imgH="6363401" progId="Prism8.Document">
                  <p:embed/>
                </p:oleObj>
              </mc:Choice>
              <mc:Fallback>
                <p:oleObj name="Prism 8" r:id="rId5" imgW="6887725" imgH="6363401" progId="Prism8.Document">
                  <p:embed/>
                  <p:pic>
                    <p:nvPicPr>
                      <p:cNvPr id="2" name="Oggetto 1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006117" y="5091175"/>
                        <a:ext cx="4969244" cy="459037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2059539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ggetto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62115895"/>
              </p:ext>
            </p:extLst>
          </p:nvPr>
        </p:nvGraphicFramePr>
        <p:xfrm>
          <a:off x="897851" y="0"/>
          <a:ext cx="5227377" cy="482882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4" name="Prism 8" r:id="rId3" imgW="6887725" imgH="6363401" progId="Prism8.Document">
                  <p:embed/>
                </p:oleObj>
              </mc:Choice>
              <mc:Fallback>
                <p:oleObj name="Prism 8" r:id="rId3" imgW="6887725" imgH="6363401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97851" y="0"/>
                        <a:ext cx="5227377" cy="482882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ggetto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67733621"/>
              </p:ext>
            </p:extLst>
          </p:nvPr>
        </p:nvGraphicFramePr>
        <p:xfrm>
          <a:off x="897851" y="4828826"/>
          <a:ext cx="5212610" cy="481518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5" name="Prism 8" r:id="rId5" imgW="6887725" imgH="6363401" progId="Prism8.Document">
                  <p:embed/>
                </p:oleObj>
              </mc:Choice>
              <mc:Fallback>
                <p:oleObj name="Prism 8" r:id="rId5" imgW="6887725" imgH="6363401" progId="Prism8.Document">
                  <p:embed/>
                  <p:pic>
                    <p:nvPicPr>
                      <p:cNvPr id="2" name="Oggetto 1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897851" y="4828826"/>
                        <a:ext cx="5212610" cy="481518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72724537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ggetto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79450293"/>
              </p:ext>
            </p:extLst>
          </p:nvPr>
        </p:nvGraphicFramePr>
        <p:xfrm>
          <a:off x="697485" y="0"/>
          <a:ext cx="5358741" cy="495017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48" name="Prism 8" r:id="rId3" imgW="6887725" imgH="6363401" progId="Prism8.Document">
                  <p:embed/>
                </p:oleObj>
              </mc:Choice>
              <mc:Fallback>
                <p:oleObj name="Prism 8" r:id="rId3" imgW="6887725" imgH="6363401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697485" y="0"/>
                        <a:ext cx="5358741" cy="495017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ggetto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2706908"/>
              </p:ext>
            </p:extLst>
          </p:nvPr>
        </p:nvGraphicFramePr>
        <p:xfrm>
          <a:off x="762153" y="4950174"/>
          <a:ext cx="5229403" cy="483069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49" name="Prism 8" r:id="rId5" imgW="6887725" imgH="6363401" progId="Prism8.Document">
                  <p:embed/>
                </p:oleObj>
              </mc:Choice>
              <mc:Fallback>
                <p:oleObj name="Prism 8" r:id="rId5" imgW="6887725" imgH="6363401" progId="Prism8.Document">
                  <p:embed/>
                  <p:pic>
                    <p:nvPicPr>
                      <p:cNvPr id="2" name="Oggetto 1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762153" y="4950174"/>
                        <a:ext cx="5229403" cy="483069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741939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ggetto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29045802"/>
              </p:ext>
            </p:extLst>
          </p:nvPr>
        </p:nvGraphicFramePr>
        <p:xfrm>
          <a:off x="555625" y="2298700"/>
          <a:ext cx="5746750" cy="5308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171" name="Prism 8" r:id="rId3" imgW="6887725" imgH="6363401" progId="Prism8.Document">
                  <p:embed/>
                </p:oleObj>
              </mc:Choice>
              <mc:Fallback>
                <p:oleObj name="Prism 8" r:id="rId3" imgW="6887725" imgH="6363401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55625" y="2298700"/>
                        <a:ext cx="5746750" cy="5308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075458243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</TotalTime>
  <Words>19</Words>
  <Application>Microsoft Office PowerPoint</Application>
  <PresentationFormat>A4 (21x29,7 cm)</PresentationFormat>
  <Paragraphs>1</Paragraphs>
  <Slides>4</Slides>
  <Notes>0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4</vt:i4>
      </vt:variant>
    </vt:vector>
  </HeadingPairs>
  <TitlesOfParts>
    <vt:vector size="10" baseType="lpstr">
      <vt:lpstr>Arial</vt:lpstr>
      <vt:lpstr>Calibri</vt:lpstr>
      <vt:lpstr>Calibri Light</vt:lpstr>
      <vt:lpstr>Times New Roman</vt:lpstr>
      <vt:lpstr>Tema di Office</vt:lpstr>
      <vt:lpstr>Prism 8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Riccardo Pagliarello</dc:creator>
  <cp:lastModifiedBy>Riccardo Pagliarello</cp:lastModifiedBy>
  <cp:revision>7</cp:revision>
  <dcterms:created xsi:type="dcterms:W3CDTF">2021-09-19T11:24:57Z</dcterms:created>
  <dcterms:modified xsi:type="dcterms:W3CDTF">2021-11-12T12:12:03Z</dcterms:modified>
</cp:coreProperties>
</file>